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3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notesSlides/_rels/notesSlide4.xml.rels" ContentType="application/vnd.openxmlformats-package.relationships+xml"/>
  <Override PartName="/ppt/notesSlides/notesSlide4.xml" ContentType="application/vnd.openxmlformats-officedocument.presentationml.notesSlide+xml"/>
  <Override PartName="/ppt/_rels/presentation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26.xml.rels" ContentType="application/vnd.openxmlformats-package.relationships+xml"/>
  <Override PartName="/ppt/slideLayouts/slideLayout29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media/image9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</p:sldMasterIdLst>
  <p:notesMasterIdLst>
    <p:notesMasterId r:id="rId5"/>
  </p:notesMasterIdLst>
  <p:sldIdLst>
    <p:sldId id="256" r:id="rId6"/>
    <p:sldId id="257" r:id="rId7"/>
    <p:sldId id="258" r:id="rId8"/>
    <p:sldId id="259" r:id="rId9"/>
    <p:sldId id="260" r:id="rId10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notesMaster" Target="notesMasters/notesMaster1.xml"/><Relationship Id="rId6" Type="http://schemas.openxmlformats.org/officeDocument/2006/relationships/slide" Target="slides/slide1.xml"/><Relationship Id="rId7" Type="http://schemas.openxmlformats.org/officeDocument/2006/relationships/slide" Target="slides/slide2.xml"/><Relationship Id="rId8" Type="http://schemas.openxmlformats.org/officeDocument/2006/relationships/slide" Target="slides/slide3.xml"/><Relationship Id="rId9" Type="http://schemas.openxmlformats.org/officeDocument/2006/relationships/slide" Target="slides/slide4.xml"/><Relationship Id="rId10" Type="http://schemas.openxmlformats.org/officeDocument/2006/relationships/slide" Target="slides/slide5.xml"/><Relationship Id="rId11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4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PlaceHolder 2"/>
          <p:cNvSpPr>
            <a:spLocks noGrp="1"/>
          </p:cNvSpPr>
          <p:nvPr>
            <p:ph type="dt" idx="10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PlaceHolder 5"/>
          <p:cNvSpPr>
            <a:spLocks noGrp="1"/>
          </p:cNvSpPr>
          <p:nvPr>
            <p:ph type="ftr" idx="11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PlaceHolder 6"/>
          <p:cNvSpPr>
            <a:spLocks noGrp="1"/>
          </p:cNvSpPr>
          <p:nvPr>
            <p:ph type="sldNum" idx="12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D539D60-49C0-489C-90B9-58430CF781D8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2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23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4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7F22E2D-B5A0-4ED9-82BB-85B29FB8FE41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5046FD-ADD8-4664-A92B-A05FE8918E2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41423A-1982-4EE6-8B39-A6B8F2DCB58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FB2B70-DBA7-4582-846C-F33A2DA4012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90D4F4-4969-498B-86DA-70F45B1B6EB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DE56557-C012-4E89-8D5E-2F206AF6671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416A57F-096C-420A-BA05-7BBC40D6FE7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E11FB57-C330-47E6-9C8F-2E74CD85D07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1AB0688-3DA3-4A69-B537-F9A3711D939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E4D3B01-9657-44DC-BD83-B6FBD912323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EBA52C4-B672-4B8B-950C-A4F28E9ABAD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11D1982-2B7A-4394-9FBD-8AE9C6BADD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B5180B-8615-4D46-87E8-30AFB43C450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9564CA8-5F30-4826-8471-6B5BE8A0CEE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1D11650-1473-4338-B5A6-7E646D04D75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62C645F-4876-49F2-9479-0B312889E2F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2C49C9A-100A-4733-AFE8-FCB5C3AAE60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C63A9DB-B496-4495-A0C2-20ACFE97C86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A3635948-D481-47D1-B4E3-4213F449F3E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9E341E05-D3AE-4470-A993-E7466E73974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E39247E5-E87D-448E-8841-742245C5C0D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BCEFC467-6774-4A68-990E-2537B1F45AC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22507579-B9AB-4167-951C-D73AF2C76BC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ACB2BF-9968-4242-B265-A33A373D965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0E7B62F4-A7DD-4769-9247-D182611D735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FCF25DFF-7A7C-4F85-8BA0-DED0EAEEAA0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8C0FF1C5-085C-44E0-A562-113BFC61A9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7DD5A97C-ACA9-4F2A-9B45-4C829023D51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4BF81449-7CE0-4506-8D6B-176273756D9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762FBD45-41FB-4127-BA2A-0E2CD46D098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0EDB8488-D7D5-4095-9F4E-E7A00F03C2F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621C00-F48C-4BC5-8F1A-BEBBDFFFE8B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E845BA-A7C9-47D1-A197-8498717AED3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DC1526-86F5-4001-8B1F-C3EAD995FF8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FE4948-C9F1-465E-BEBD-B20D3B42248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E6A4F0-04AC-4DAB-B32E-61A2CCEF10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1A3B9C-66DE-414C-9FE3-604D2C1D868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30E8308-32B6-4CA0-9C32-D81871FB3F85}" type="datetime">
              <a:rPr b="0" lang="en-GB" sz="1200" spc="-1" strike="noStrike">
                <a:solidFill>
                  <a:srgbClr val="898989"/>
                </a:solidFill>
                <a:latin typeface="Calibri"/>
              </a:rPr>
              <a:t>29/08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708C01B-DD50-49B8-B485-8C9C0FBD79EF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ED464F3-EE3C-44CB-A420-91E7D08E9A67}" type="datetime">
              <a:rPr b="0" lang="en-GB" sz="1200" spc="-1" strike="noStrike">
                <a:solidFill>
                  <a:srgbClr val="898989"/>
                </a:solidFill>
                <a:latin typeface="Calibri"/>
              </a:rPr>
              <a:t>29/08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FF1E20F-3B95-41DC-A9C3-1352545C0DBC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PlaceHolder 3"/>
          <p:cNvSpPr>
            <a:spLocks noGrp="1"/>
          </p:cNvSpPr>
          <p:nvPr>
            <p:ph type="dt" idx="7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7F9BDA7-9278-44EB-BEB3-5980615F1FA2}" type="datetime">
              <a:rPr b="0" lang="en-GB" sz="1200" spc="-1" strike="noStrike">
                <a:solidFill>
                  <a:srgbClr val="898989"/>
                </a:solidFill>
                <a:latin typeface="Calibri"/>
              </a:rPr>
              <a:t>29/08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PlaceHolder 4"/>
          <p:cNvSpPr>
            <a:spLocks noGrp="1"/>
          </p:cNvSpPr>
          <p:nvPr>
            <p:ph type="ftr" idx="8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PlaceHolder 5"/>
          <p:cNvSpPr>
            <a:spLocks noGrp="1"/>
          </p:cNvSpPr>
          <p:nvPr>
            <p:ph type="sldNum" idx="9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19D91CF-DB52-4DB0-8302-208F7BA6FA19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5.png"/><Relationship Id="rId3" Type="http://schemas.openxmlformats.org/officeDocument/2006/relationships/image" Target="../media/image5.png"/><Relationship Id="rId4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png"/><Relationship Id="rId3" Type="http://schemas.openxmlformats.org/officeDocument/2006/relationships/image" Target="../media/image9.png"/><Relationship Id="rId4" Type="http://schemas.openxmlformats.org/officeDocument/2006/relationships/image" Target="../media/image10.png"/><Relationship Id="rId5" Type="http://schemas.openxmlformats.org/officeDocument/2006/relationships/image" Target="../media/image11.png"/><Relationship Id="rId6" Type="http://schemas.openxmlformats.org/officeDocument/2006/relationships/image" Target="../media/image12.png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Slide Number Placeholder 1"/>
          <p:cNvSpPr/>
          <p:nvPr/>
        </p:nvSpPr>
        <p:spPr>
          <a:xfrm>
            <a:off x="4915080" y="8475840"/>
            <a:ext cx="1600200" cy="48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1" name="Picture 4" descr=""/>
          <p:cNvPicPr/>
          <p:nvPr/>
        </p:nvPicPr>
        <p:blipFill>
          <a:blip r:embed="rId1"/>
          <a:srcRect l="35517" t="43328" r="48069" b="37992"/>
          <a:stretch/>
        </p:blipFill>
        <p:spPr>
          <a:xfrm>
            <a:off x="2741760" y="2556000"/>
            <a:ext cx="100944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32" name="Text Box 1119"/>
          <p:cNvSpPr/>
          <p:nvPr/>
        </p:nvSpPr>
        <p:spPr>
          <a:xfrm rot="16200000">
            <a:off x="2521080" y="1896840"/>
            <a:ext cx="974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Wild typ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Text Box 1119"/>
          <p:cNvSpPr/>
          <p:nvPr/>
        </p:nvSpPr>
        <p:spPr>
          <a:xfrm rot="16200000">
            <a:off x="2979720" y="1896840"/>
            <a:ext cx="974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RASSF1A</a:t>
            </a:r>
            <a:r>
              <a:rPr b="0" lang="en-GB" sz="1200" spc="-1" strike="noStrike" baseline="30000">
                <a:solidFill>
                  <a:srgbClr val="000000"/>
                </a:solidFill>
                <a:latin typeface="Calibri"/>
              </a:rPr>
              <a:t>-/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4" name="Picture 5" descr=""/>
          <p:cNvPicPr/>
          <p:nvPr/>
        </p:nvPicPr>
        <p:blipFill>
          <a:blip r:embed="rId2"/>
          <a:srcRect l="53867" t="66155" r="30004" b="19972"/>
          <a:stretch/>
        </p:blipFill>
        <p:spPr>
          <a:xfrm>
            <a:off x="2741760" y="3995640"/>
            <a:ext cx="99036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35" name="Picture 6" descr=""/>
          <p:cNvPicPr/>
          <p:nvPr/>
        </p:nvPicPr>
        <p:blipFill>
          <a:blip r:embed="rId3"/>
          <a:srcRect l="69315" t="65377" r="13310" b="23415"/>
          <a:stretch/>
        </p:blipFill>
        <p:spPr>
          <a:xfrm>
            <a:off x="2741760" y="3025800"/>
            <a:ext cx="100800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36" name="Picture 7" descr=""/>
          <p:cNvPicPr/>
          <p:nvPr/>
        </p:nvPicPr>
        <p:blipFill>
          <a:blip r:embed="rId4"/>
          <a:srcRect l="68495" t="75015" r="15091" b="16317"/>
          <a:stretch/>
        </p:blipFill>
        <p:spPr>
          <a:xfrm>
            <a:off x="2757600" y="3500280"/>
            <a:ext cx="96048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37" name="TextBox 10"/>
          <p:cNvSpPr/>
          <p:nvPr/>
        </p:nvSpPr>
        <p:spPr>
          <a:xfrm>
            <a:off x="3716280" y="2622600"/>
            <a:ext cx="649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TNFR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TextBox 11"/>
          <p:cNvSpPr/>
          <p:nvPr/>
        </p:nvSpPr>
        <p:spPr>
          <a:xfrm>
            <a:off x="3716280" y="3033720"/>
            <a:ext cx="649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TRAD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TextBox 12"/>
          <p:cNvSpPr/>
          <p:nvPr/>
        </p:nvSpPr>
        <p:spPr>
          <a:xfrm>
            <a:off x="3699000" y="4052880"/>
            <a:ext cx="647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GAPD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TextBox 15"/>
          <p:cNvSpPr/>
          <p:nvPr/>
        </p:nvSpPr>
        <p:spPr>
          <a:xfrm>
            <a:off x="3699000" y="3557520"/>
            <a:ext cx="647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TRAF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TextBox 20"/>
          <p:cNvSpPr/>
          <p:nvPr/>
        </p:nvSpPr>
        <p:spPr>
          <a:xfrm>
            <a:off x="2133720" y="324000"/>
            <a:ext cx="2447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</a:rPr>
              <a:t>Supplementary Figure 1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Rectangle 1"/>
          <p:cNvSpPr/>
          <p:nvPr/>
        </p:nvSpPr>
        <p:spPr>
          <a:xfrm>
            <a:off x="182520" y="4861080"/>
            <a:ext cx="6551640" cy="59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Times New Roman"/>
                <a:ea typeface="Calibri"/>
              </a:rPr>
              <a:t>Supplementary Figure 1 Expression of TNFR1, TRADD and TRAF2 in WT and RASSF1A</a:t>
            </a:r>
            <a:r>
              <a:rPr b="1" lang="en-GB" sz="1100" spc="-1" strike="noStrike" baseline="30000">
                <a:solidFill>
                  <a:srgbClr val="000000"/>
                </a:solidFill>
                <a:latin typeface="Times New Roman"/>
                <a:ea typeface="Calibri"/>
              </a:rPr>
              <a:t>-/-</a:t>
            </a:r>
            <a:r>
              <a:rPr b="1" lang="en-GB" sz="1100" spc="-1" strike="noStrike">
                <a:solidFill>
                  <a:srgbClr val="000000"/>
                </a:solidFill>
                <a:latin typeface="Times New Roman"/>
                <a:ea typeface="Calibri"/>
              </a:rPr>
              <a:t>. </a:t>
            </a:r>
            <a:r>
              <a:rPr b="0" lang="en-GB" sz="1100" spc="-1" strike="noStrike">
                <a:solidFill>
                  <a:srgbClr val="000000"/>
                </a:solidFill>
                <a:latin typeface="Times New Roman"/>
                <a:ea typeface="Calibri"/>
              </a:rPr>
              <a:t>Western blot analysis showed that the levels of TNFR1, TRADD and TRAF2 expression were comparable between WT and RASSF1A</a:t>
            </a:r>
            <a:r>
              <a:rPr b="0" lang="en-GB" sz="1100" spc="-1" strike="noStrike" baseline="30000">
                <a:solidFill>
                  <a:srgbClr val="000000"/>
                </a:solidFill>
                <a:latin typeface="Times New Roman"/>
                <a:ea typeface="Calibri"/>
              </a:rPr>
              <a:t>-/-</a:t>
            </a:r>
            <a:r>
              <a:rPr b="0" lang="en-GB" sz="1100" spc="-1" strike="noStrike">
                <a:solidFill>
                  <a:srgbClr val="000000"/>
                </a:solidFill>
                <a:latin typeface="Times New Roman"/>
                <a:ea typeface="Calibri"/>
              </a:rPr>
              <a:t> cardiomyocytes. 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" name="Slide Number Placeholder 1"/>
          <p:cNvSpPr/>
          <p:nvPr/>
        </p:nvSpPr>
        <p:spPr>
          <a:xfrm>
            <a:off x="4915080" y="8475840"/>
            <a:ext cx="1600200" cy="48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4" name="Picture 2" descr="truncation constructs.png"/>
          <p:cNvPicPr/>
          <p:nvPr/>
        </p:nvPicPr>
        <p:blipFill>
          <a:blip r:embed="rId1"/>
          <a:srcRect l="3020" t="26524" r="7462" b="40915"/>
          <a:stretch/>
        </p:blipFill>
        <p:spPr>
          <a:xfrm>
            <a:off x="463680" y="3203640"/>
            <a:ext cx="3782880" cy="1224000"/>
          </a:xfrm>
          <a:prstGeom prst="rect">
            <a:avLst/>
          </a:prstGeom>
          <a:ln w="0">
            <a:noFill/>
          </a:ln>
        </p:spPr>
      </p:pic>
      <p:pic>
        <p:nvPicPr>
          <p:cNvPr id="145" name="Picture 3" descr="truncation constructs.png"/>
          <p:cNvPicPr/>
          <p:nvPr/>
        </p:nvPicPr>
        <p:blipFill>
          <a:blip r:embed="rId2"/>
          <a:srcRect l="3020" t="11724" r="7462" b="73481"/>
          <a:stretch/>
        </p:blipFill>
        <p:spPr>
          <a:xfrm>
            <a:off x="260280" y="2195640"/>
            <a:ext cx="4152960" cy="556920"/>
          </a:xfrm>
          <a:prstGeom prst="rect">
            <a:avLst/>
          </a:prstGeom>
          <a:ln w="0">
            <a:noFill/>
          </a:ln>
        </p:spPr>
      </p:pic>
      <p:sp>
        <p:nvSpPr>
          <p:cNvPr id="146" name="TextBox 4"/>
          <p:cNvSpPr/>
          <p:nvPr/>
        </p:nvSpPr>
        <p:spPr>
          <a:xfrm>
            <a:off x="4514760" y="2340000"/>
            <a:ext cx="86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RASSF1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TextBox 5"/>
          <p:cNvSpPr/>
          <p:nvPr/>
        </p:nvSpPr>
        <p:spPr>
          <a:xfrm>
            <a:off x="4508640" y="3430440"/>
            <a:ext cx="122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RASSF1A-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TextBox 6"/>
          <p:cNvSpPr/>
          <p:nvPr/>
        </p:nvSpPr>
        <p:spPr>
          <a:xfrm>
            <a:off x="4508640" y="4078440"/>
            <a:ext cx="122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RASSF1A-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C+R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TextBox 7"/>
          <p:cNvSpPr/>
          <p:nvPr/>
        </p:nvSpPr>
        <p:spPr>
          <a:xfrm>
            <a:off x="4508640" y="2854440"/>
            <a:ext cx="122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RASSF1A-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0" name="Picture 8" descr="truncation constructs.png"/>
          <p:cNvPicPr/>
          <p:nvPr/>
        </p:nvPicPr>
        <p:blipFill>
          <a:blip r:embed="rId3"/>
          <a:srcRect l="3020" t="59091" r="7462" b="26109"/>
          <a:stretch/>
        </p:blipFill>
        <p:spPr>
          <a:xfrm>
            <a:off x="287280" y="2700360"/>
            <a:ext cx="4152960" cy="555480"/>
          </a:xfrm>
          <a:prstGeom prst="rect">
            <a:avLst/>
          </a:prstGeom>
          <a:ln w="0">
            <a:noFill/>
          </a:ln>
        </p:spPr>
      </p:pic>
      <p:sp>
        <p:nvSpPr>
          <p:cNvPr id="151" name="TextBox 9"/>
          <p:cNvSpPr/>
          <p:nvPr/>
        </p:nvSpPr>
        <p:spPr>
          <a:xfrm>
            <a:off x="2133720" y="324000"/>
            <a:ext cx="2447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</a:rPr>
              <a:t>Supplementary Figure 2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Rectangle 1"/>
          <p:cNvSpPr/>
          <p:nvPr/>
        </p:nvSpPr>
        <p:spPr>
          <a:xfrm>
            <a:off x="220680" y="4788000"/>
            <a:ext cx="65530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Times New Roman"/>
                <a:ea typeface="Calibri"/>
              </a:rPr>
              <a:t>Supplementary Figure 2. </a:t>
            </a:r>
            <a:r>
              <a:rPr b="0" lang="en-GB" sz="1100" spc="-1" strike="noStrike">
                <a:solidFill>
                  <a:srgbClr val="000000"/>
                </a:solidFill>
                <a:latin typeface="Times New Roman"/>
                <a:ea typeface="Calibri"/>
              </a:rPr>
              <a:t>Schematic diagram of the Flag-tagged RASSF1A deletion constructs. </a:t>
            </a:r>
            <a:r>
              <a:rPr b="1" lang="en-GB" sz="1100" spc="-1" strike="noStrike">
                <a:solidFill>
                  <a:srgbClr val="000000"/>
                </a:solidFill>
                <a:latin typeface="Times New Roman"/>
                <a:ea typeface="Calibri"/>
              </a:rPr>
              <a:t>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" name="Chart 7" descr=""/>
          <p:cNvPicPr/>
          <p:nvPr/>
        </p:nvPicPr>
        <p:blipFill>
          <a:blip r:embed="rId1"/>
          <a:stretch/>
        </p:blipFill>
        <p:spPr>
          <a:xfrm>
            <a:off x="1122480" y="2193840"/>
            <a:ext cx="3370320" cy="2165400"/>
          </a:xfrm>
          <a:prstGeom prst="rect">
            <a:avLst/>
          </a:prstGeom>
          <a:ln w="0">
            <a:noFill/>
          </a:ln>
        </p:spPr>
      </p:pic>
      <p:sp>
        <p:nvSpPr>
          <p:cNvPr id="154" name="Slide Number Placeholder 1"/>
          <p:cNvSpPr/>
          <p:nvPr/>
        </p:nvSpPr>
        <p:spPr>
          <a:xfrm>
            <a:off x="4915080" y="8475840"/>
            <a:ext cx="1600200" cy="48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TextBox 3"/>
          <p:cNvSpPr/>
          <p:nvPr/>
        </p:nvSpPr>
        <p:spPr>
          <a:xfrm>
            <a:off x="2349360" y="539640"/>
            <a:ext cx="2374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</a:rPr>
              <a:t>Supplementary figure 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TextBox 4"/>
          <p:cNvSpPr/>
          <p:nvPr/>
        </p:nvSpPr>
        <p:spPr>
          <a:xfrm>
            <a:off x="2276640" y="2330280"/>
            <a:ext cx="431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TextBox 5"/>
          <p:cNvSpPr/>
          <p:nvPr/>
        </p:nvSpPr>
        <p:spPr>
          <a:xfrm>
            <a:off x="3573360" y="2340000"/>
            <a:ext cx="432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TextBox 6"/>
          <p:cNvSpPr/>
          <p:nvPr/>
        </p:nvSpPr>
        <p:spPr>
          <a:xfrm rot="16200000">
            <a:off x="-278640" y="2927880"/>
            <a:ext cx="2447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Calibri"/>
              </a:rPr>
              <a:t>CaMKII activity (unit / mg protein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Text Box 1121"/>
          <p:cNvSpPr/>
          <p:nvPr/>
        </p:nvSpPr>
        <p:spPr>
          <a:xfrm>
            <a:off x="1231920" y="4222800"/>
            <a:ext cx="2952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TNF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           -                 +                 -                 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Text Box 1120"/>
          <p:cNvSpPr/>
          <p:nvPr/>
        </p:nvSpPr>
        <p:spPr>
          <a:xfrm>
            <a:off x="3284640" y="4427640"/>
            <a:ext cx="104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</a:rPr>
              <a:t>RASSF1A</a:t>
            </a:r>
            <a:r>
              <a:rPr b="0" lang="en-GB" sz="1400" spc="-1" strike="noStrike" baseline="30000">
                <a:solidFill>
                  <a:srgbClr val="000000"/>
                </a:solidFill>
                <a:latin typeface="Calibri"/>
              </a:rPr>
              <a:t>-/-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Text Box 1119"/>
          <p:cNvSpPr/>
          <p:nvPr/>
        </p:nvSpPr>
        <p:spPr>
          <a:xfrm>
            <a:off x="1989000" y="4427640"/>
            <a:ext cx="974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</a:rPr>
              <a:t>Wild typ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TextBox 11"/>
          <p:cNvSpPr/>
          <p:nvPr/>
        </p:nvSpPr>
        <p:spPr>
          <a:xfrm>
            <a:off x="333360" y="4832280"/>
            <a:ext cx="6191280" cy="76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3 Analysis of CamKII activity.</a:t>
            </a:r>
            <a:r>
              <a:rPr b="0" lang="en-GB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CamKII activity was measured in adult cardiomyocytes isolated from WT and RASSF1A</a:t>
            </a:r>
            <a:r>
              <a:rPr b="0" lang="en-GB" sz="11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-/- </a:t>
            </a:r>
            <a:r>
              <a:rPr b="0" lang="en-GB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ice. Treatment with TNF-</a:t>
            </a:r>
            <a:r>
              <a:rPr b="0" lang="el-GR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α</a:t>
            </a:r>
            <a:r>
              <a:rPr b="0" lang="en-GB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(10 ng/ml) for 30 minutes significantly enhanced CaMKII activity, however, no difference was observed between WT and RASSF1A</a:t>
            </a:r>
            <a:r>
              <a:rPr b="0" lang="en-GB" sz="11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-/- </a:t>
            </a:r>
            <a:r>
              <a:rPr b="0" lang="en-GB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yocytes (*P&lt; 0.05; n= 6 animals in each group)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3" name="Group 12"/>
          <p:cNvGrpSpPr/>
          <p:nvPr/>
        </p:nvGrpSpPr>
        <p:grpSpPr>
          <a:xfrm>
            <a:off x="2133720" y="2576520"/>
            <a:ext cx="574560" cy="50760"/>
            <a:chOff x="2133720" y="2576520"/>
            <a:chExt cx="574560" cy="50760"/>
          </a:xfrm>
        </p:grpSpPr>
        <p:sp>
          <p:nvSpPr>
            <p:cNvPr id="164" name="Straight Connector 13"/>
            <p:cNvSpPr/>
            <p:nvPr/>
          </p:nvSpPr>
          <p:spPr>
            <a:xfrm>
              <a:off x="2133720" y="2576520"/>
              <a:ext cx="5745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Straight Connector 14"/>
            <p:cNvSpPr/>
            <p:nvPr/>
          </p:nvSpPr>
          <p:spPr>
            <a:xfrm>
              <a:off x="2133720" y="2576520"/>
              <a:ext cx="0" cy="50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Straight Connector 15"/>
            <p:cNvSpPr/>
            <p:nvPr/>
          </p:nvSpPr>
          <p:spPr>
            <a:xfrm>
              <a:off x="2708280" y="2576520"/>
              <a:ext cx="0" cy="50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67" name="Group 17"/>
          <p:cNvGrpSpPr/>
          <p:nvPr/>
        </p:nvGrpSpPr>
        <p:grpSpPr>
          <a:xfrm>
            <a:off x="3429000" y="2627280"/>
            <a:ext cx="576360" cy="52560"/>
            <a:chOff x="3429000" y="2627280"/>
            <a:chExt cx="576360" cy="52560"/>
          </a:xfrm>
        </p:grpSpPr>
        <p:sp>
          <p:nvSpPr>
            <p:cNvPr id="168" name="Straight Connector 18"/>
            <p:cNvSpPr/>
            <p:nvPr/>
          </p:nvSpPr>
          <p:spPr>
            <a:xfrm>
              <a:off x="3429000" y="2627280"/>
              <a:ext cx="57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Straight Connector 19"/>
            <p:cNvSpPr/>
            <p:nvPr/>
          </p:nvSpPr>
          <p:spPr>
            <a:xfrm>
              <a:off x="3429000" y="2627280"/>
              <a:ext cx="0" cy="52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60" bIns="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Straight Connector 20"/>
            <p:cNvSpPr/>
            <p:nvPr/>
          </p:nvSpPr>
          <p:spPr>
            <a:xfrm>
              <a:off x="4005360" y="2627280"/>
              <a:ext cx="0" cy="52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60" bIns="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Slide Number Placeholder 1"/>
          <p:cNvSpPr/>
          <p:nvPr/>
        </p:nvSpPr>
        <p:spPr>
          <a:xfrm>
            <a:off x="4915080" y="8475840"/>
            <a:ext cx="1600200" cy="48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72" name="Chart 2" descr=""/>
          <p:cNvPicPr/>
          <p:nvPr/>
        </p:nvPicPr>
        <p:blipFill>
          <a:blip r:embed="rId1"/>
          <a:stretch/>
        </p:blipFill>
        <p:spPr>
          <a:xfrm>
            <a:off x="835200" y="1116000"/>
            <a:ext cx="2577960" cy="1730520"/>
          </a:xfrm>
          <a:prstGeom prst="rect">
            <a:avLst/>
          </a:prstGeom>
          <a:ln w="0">
            <a:noFill/>
          </a:ln>
        </p:spPr>
      </p:pic>
      <p:sp>
        <p:nvSpPr>
          <p:cNvPr id="173" name="Text Box 1121"/>
          <p:cNvSpPr/>
          <p:nvPr/>
        </p:nvSpPr>
        <p:spPr>
          <a:xfrm>
            <a:off x="907920" y="2720880"/>
            <a:ext cx="2952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LPS         -            +             -             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Text Box 1120"/>
          <p:cNvSpPr/>
          <p:nvPr/>
        </p:nvSpPr>
        <p:spPr>
          <a:xfrm>
            <a:off x="2276640" y="2916360"/>
            <a:ext cx="1049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</a:rPr>
              <a:t>RASSF1A</a:t>
            </a:r>
            <a:r>
              <a:rPr b="0" lang="en-GB" sz="1400" spc="-1" strike="noStrike" baseline="30000">
                <a:solidFill>
                  <a:srgbClr val="000000"/>
                </a:solidFill>
                <a:latin typeface="Calibri"/>
              </a:rPr>
              <a:t>-/-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Text Box 1119"/>
          <p:cNvSpPr/>
          <p:nvPr/>
        </p:nvSpPr>
        <p:spPr>
          <a:xfrm>
            <a:off x="1268280" y="2916360"/>
            <a:ext cx="974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</a:rPr>
              <a:t>Wild typ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TextBox 6"/>
          <p:cNvSpPr/>
          <p:nvPr/>
        </p:nvSpPr>
        <p:spPr>
          <a:xfrm>
            <a:off x="1844640" y="826920"/>
            <a:ext cx="1224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cPLA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77" name="Chart 7" descr=""/>
          <p:cNvPicPr/>
          <p:nvPr/>
        </p:nvPicPr>
        <p:blipFill>
          <a:blip r:embed="rId2"/>
          <a:stretch/>
        </p:blipFill>
        <p:spPr>
          <a:xfrm>
            <a:off x="3638520" y="1116000"/>
            <a:ext cx="2457360" cy="1730520"/>
          </a:xfrm>
          <a:prstGeom prst="rect">
            <a:avLst/>
          </a:prstGeom>
          <a:ln w="0">
            <a:noFill/>
          </a:ln>
        </p:spPr>
      </p:pic>
      <p:sp>
        <p:nvSpPr>
          <p:cNvPr id="178" name="Text Box 1121"/>
          <p:cNvSpPr/>
          <p:nvPr/>
        </p:nvSpPr>
        <p:spPr>
          <a:xfrm>
            <a:off x="3716280" y="2700360"/>
            <a:ext cx="2952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LPS         -            +           -            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Text Box 1120"/>
          <p:cNvSpPr/>
          <p:nvPr/>
        </p:nvSpPr>
        <p:spPr>
          <a:xfrm>
            <a:off x="5086440" y="2894040"/>
            <a:ext cx="104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</a:rPr>
              <a:t>RASSF1A</a:t>
            </a:r>
            <a:r>
              <a:rPr b="0" lang="en-GB" sz="1400" spc="-1" strike="noStrike" baseline="30000">
                <a:solidFill>
                  <a:srgbClr val="000000"/>
                </a:solidFill>
                <a:latin typeface="Calibri"/>
              </a:rPr>
              <a:t>-/-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Text Box 1119"/>
          <p:cNvSpPr/>
          <p:nvPr/>
        </p:nvSpPr>
        <p:spPr>
          <a:xfrm>
            <a:off x="4078440" y="2894040"/>
            <a:ext cx="974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</a:rPr>
              <a:t>Wild typ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81" name="Picture 2" descr=""/>
          <p:cNvPicPr/>
          <p:nvPr/>
        </p:nvPicPr>
        <p:blipFill>
          <a:blip r:embed="rId3"/>
          <a:srcRect l="37438" t="22108" r="17177" b="69091"/>
          <a:stretch/>
        </p:blipFill>
        <p:spPr>
          <a:xfrm>
            <a:off x="1258920" y="4295880"/>
            <a:ext cx="2530440" cy="3222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82" name="Picture 3" descr=""/>
          <p:cNvPicPr/>
          <p:nvPr/>
        </p:nvPicPr>
        <p:blipFill>
          <a:blip r:embed="rId4"/>
          <a:srcRect l="21985" t="52943" r="32630" b="33852"/>
          <a:stretch/>
        </p:blipFill>
        <p:spPr>
          <a:xfrm>
            <a:off x="1268280" y="4735440"/>
            <a:ext cx="2521080" cy="4842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83" name="TextBox 14"/>
          <p:cNvSpPr/>
          <p:nvPr/>
        </p:nvSpPr>
        <p:spPr>
          <a:xfrm>
            <a:off x="3933720" y="6156360"/>
            <a:ext cx="1441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p-RY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84" name="Picture 4" descr=""/>
          <p:cNvPicPr/>
          <p:nvPr/>
        </p:nvPicPr>
        <p:blipFill>
          <a:blip r:embed="rId5"/>
          <a:srcRect l="21985" t="57347" r="32630" b="26512"/>
          <a:stretch/>
        </p:blipFill>
        <p:spPr>
          <a:xfrm>
            <a:off x="1268280" y="6699240"/>
            <a:ext cx="2629080" cy="4478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85" name="Picture 6" descr=""/>
          <p:cNvPicPr/>
          <p:nvPr/>
        </p:nvPicPr>
        <p:blipFill>
          <a:blip r:embed="rId6"/>
          <a:srcRect l="37231" t="19172" r="18350" b="72027"/>
          <a:stretch/>
        </p:blipFill>
        <p:spPr>
          <a:xfrm>
            <a:off x="1258920" y="6186600"/>
            <a:ext cx="2628720" cy="342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86" name="TextBox 19"/>
          <p:cNvSpPr/>
          <p:nvPr/>
        </p:nvSpPr>
        <p:spPr>
          <a:xfrm>
            <a:off x="3789360" y="4303800"/>
            <a:ext cx="1440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p-LTC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TextBox 6"/>
          <p:cNvSpPr/>
          <p:nvPr/>
        </p:nvSpPr>
        <p:spPr>
          <a:xfrm>
            <a:off x="4653000" y="826920"/>
            <a:ext cx="1224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PK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TextBox 22"/>
          <p:cNvSpPr/>
          <p:nvPr/>
        </p:nvSpPr>
        <p:spPr>
          <a:xfrm>
            <a:off x="1125360" y="3943440"/>
            <a:ext cx="2880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WT   KO   WT   KO   WT   KO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89" name="Group 28"/>
          <p:cNvGrpSpPr/>
          <p:nvPr/>
        </p:nvGrpSpPr>
        <p:grpSpPr>
          <a:xfrm>
            <a:off x="1341360" y="3871800"/>
            <a:ext cx="647640" cy="71640"/>
            <a:chOff x="1341360" y="3871800"/>
            <a:chExt cx="647640" cy="71640"/>
          </a:xfrm>
        </p:grpSpPr>
        <p:sp>
          <p:nvSpPr>
            <p:cNvPr id="190" name="Straight Connector 24"/>
            <p:cNvSpPr/>
            <p:nvPr/>
          </p:nvSpPr>
          <p:spPr>
            <a:xfrm>
              <a:off x="1341360" y="3871800"/>
              <a:ext cx="647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Straight Connector 26"/>
            <p:cNvSpPr/>
            <p:nvPr/>
          </p:nvSpPr>
          <p:spPr>
            <a:xfrm>
              <a:off x="1341360" y="3871800"/>
              <a:ext cx="0" cy="71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Straight Connector 27"/>
            <p:cNvSpPr/>
            <p:nvPr/>
          </p:nvSpPr>
          <p:spPr>
            <a:xfrm>
              <a:off x="1989000" y="3871800"/>
              <a:ext cx="0" cy="71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93" name="Group 29"/>
          <p:cNvGrpSpPr/>
          <p:nvPr/>
        </p:nvGrpSpPr>
        <p:grpSpPr>
          <a:xfrm>
            <a:off x="2205000" y="3871800"/>
            <a:ext cx="647640" cy="71640"/>
            <a:chOff x="2205000" y="3871800"/>
            <a:chExt cx="647640" cy="71640"/>
          </a:xfrm>
        </p:grpSpPr>
        <p:sp>
          <p:nvSpPr>
            <p:cNvPr id="194" name="Straight Connector 30"/>
            <p:cNvSpPr/>
            <p:nvPr/>
          </p:nvSpPr>
          <p:spPr>
            <a:xfrm>
              <a:off x="2205000" y="3871800"/>
              <a:ext cx="647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Straight Connector 31"/>
            <p:cNvSpPr/>
            <p:nvPr/>
          </p:nvSpPr>
          <p:spPr>
            <a:xfrm>
              <a:off x="2205000" y="3871800"/>
              <a:ext cx="0" cy="71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Straight Connector 32"/>
            <p:cNvSpPr/>
            <p:nvPr/>
          </p:nvSpPr>
          <p:spPr>
            <a:xfrm>
              <a:off x="2852640" y="3871800"/>
              <a:ext cx="0" cy="71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97" name="Group 33"/>
          <p:cNvGrpSpPr/>
          <p:nvPr/>
        </p:nvGrpSpPr>
        <p:grpSpPr>
          <a:xfrm>
            <a:off x="2997360" y="3871800"/>
            <a:ext cx="647640" cy="71640"/>
            <a:chOff x="2997360" y="3871800"/>
            <a:chExt cx="647640" cy="71640"/>
          </a:xfrm>
        </p:grpSpPr>
        <p:sp>
          <p:nvSpPr>
            <p:cNvPr id="198" name="Straight Connector 34"/>
            <p:cNvSpPr/>
            <p:nvPr/>
          </p:nvSpPr>
          <p:spPr>
            <a:xfrm>
              <a:off x="2997360" y="3871800"/>
              <a:ext cx="647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Straight Connector 35"/>
            <p:cNvSpPr/>
            <p:nvPr/>
          </p:nvSpPr>
          <p:spPr>
            <a:xfrm>
              <a:off x="2997360" y="3871800"/>
              <a:ext cx="0" cy="71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Straight Connector 36"/>
            <p:cNvSpPr/>
            <p:nvPr/>
          </p:nvSpPr>
          <p:spPr>
            <a:xfrm>
              <a:off x="3645000" y="3871800"/>
              <a:ext cx="0" cy="71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01" name="TextBox 37"/>
          <p:cNvSpPr/>
          <p:nvPr/>
        </p:nvSpPr>
        <p:spPr>
          <a:xfrm>
            <a:off x="1484280" y="3583080"/>
            <a:ext cx="576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Iso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TextBox 38"/>
          <p:cNvSpPr/>
          <p:nvPr/>
        </p:nvSpPr>
        <p:spPr>
          <a:xfrm>
            <a:off x="2276640" y="3583080"/>
            <a:ext cx="576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LP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TextBox 39"/>
          <p:cNvSpPr/>
          <p:nvPr/>
        </p:nvSpPr>
        <p:spPr>
          <a:xfrm>
            <a:off x="3068640" y="3564000"/>
            <a:ext cx="576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Ctr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TextBox 19"/>
          <p:cNvSpPr/>
          <p:nvPr/>
        </p:nvSpPr>
        <p:spPr>
          <a:xfrm>
            <a:off x="3789360" y="4788000"/>
            <a:ext cx="1440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t-LTC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TextBox 41"/>
          <p:cNvSpPr/>
          <p:nvPr/>
        </p:nvSpPr>
        <p:spPr>
          <a:xfrm>
            <a:off x="1197000" y="5888160"/>
            <a:ext cx="2879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WT   KO   WT   KO   WT   KO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06" name="Group 42"/>
          <p:cNvGrpSpPr/>
          <p:nvPr/>
        </p:nvGrpSpPr>
        <p:grpSpPr>
          <a:xfrm>
            <a:off x="1413000" y="5816520"/>
            <a:ext cx="647640" cy="71640"/>
            <a:chOff x="1413000" y="5816520"/>
            <a:chExt cx="647640" cy="71640"/>
          </a:xfrm>
        </p:grpSpPr>
        <p:sp>
          <p:nvSpPr>
            <p:cNvPr id="207" name="Straight Connector 43"/>
            <p:cNvSpPr/>
            <p:nvPr/>
          </p:nvSpPr>
          <p:spPr>
            <a:xfrm>
              <a:off x="1413000" y="5816520"/>
              <a:ext cx="647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Straight Connector 44"/>
            <p:cNvSpPr/>
            <p:nvPr/>
          </p:nvSpPr>
          <p:spPr>
            <a:xfrm>
              <a:off x="1413000" y="5816520"/>
              <a:ext cx="0" cy="71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Straight Connector 45"/>
            <p:cNvSpPr/>
            <p:nvPr/>
          </p:nvSpPr>
          <p:spPr>
            <a:xfrm>
              <a:off x="2060640" y="5816520"/>
              <a:ext cx="0" cy="71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10" name="Group 46"/>
          <p:cNvGrpSpPr/>
          <p:nvPr/>
        </p:nvGrpSpPr>
        <p:grpSpPr>
          <a:xfrm>
            <a:off x="2276640" y="5816520"/>
            <a:ext cx="647640" cy="71640"/>
            <a:chOff x="2276640" y="5816520"/>
            <a:chExt cx="647640" cy="71640"/>
          </a:xfrm>
        </p:grpSpPr>
        <p:sp>
          <p:nvSpPr>
            <p:cNvPr id="211" name="Straight Connector 47"/>
            <p:cNvSpPr/>
            <p:nvPr/>
          </p:nvSpPr>
          <p:spPr>
            <a:xfrm>
              <a:off x="2276640" y="5816520"/>
              <a:ext cx="647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Straight Connector 48"/>
            <p:cNvSpPr/>
            <p:nvPr/>
          </p:nvSpPr>
          <p:spPr>
            <a:xfrm>
              <a:off x="2276640" y="5816520"/>
              <a:ext cx="0" cy="71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Straight Connector 49"/>
            <p:cNvSpPr/>
            <p:nvPr/>
          </p:nvSpPr>
          <p:spPr>
            <a:xfrm>
              <a:off x="2924280" y="5816520"/>
              <a:ext cx="0" cy="71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14" name="Group 50"/>
          <p:cNvGrpSpPr/>
          <p:nvPr/>
        </p:nvGrpSpPr>
        <p:grpSpPr>
          <a:xfrm>
            <a:off x="3068640" y="5816520"/>
            <a:ext cx="647640" cy="71640"/>
            <a:chOff x="3068640" y="5816520"/>
            <a:chExt cx="647640" cy="71640"/>
          </a:xfrm>
        </p:grpSpPr>
        <p:sp>
          <p:nvSpPr>
            <p:cNvPr id="215" name="Straight Connector 51"/>
            <p:cNvSpPr/>
            <p:nvPr/>
          </p:nvSpPr>
          <p:spPr>
            <a:xfrm>
              <a:off x="3068640" y="5816520"/>
              <a:ext cx="647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Straight Connector 52"/>
            <p:cNvSpPr/>
            <p:nvPr/>
          </p:nvSpPr>
          <p:spPr>
            <a:xfrm>
              <a:off x="3068640" y="5816520"/>
              <a:ext cx="0" cy="71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Straight Connector 53"/>
            <p:cNvSpPr/>
            <p:nvPr/>
          </p:nvSpPr>
          <p:spPr>
            <a:xfrm>
              <a:off x="3716280" y="5816520"/>
              <a:ext cx="0" cy="71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18" name="TextBox 54"/>
          <p:cNvSpPr/>
          <p:nvPr/>
        </p:nvSpPr>
        <p:spPr>
          <a:xfrm>
            <a:off x="1557360" y="5527800"/>
            <a:ext cx="576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Iso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TextBox 55"/>
          <p:cNvSpPr/>
          <p:nvPr/>
        </p:nvSpPr>
        <p:spPr>
          <a:xfrm>
            <a:off x="2349360" y="5527800"/>
            <a:ext cx="574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LP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TextBox 56"/>
          <p:cNvSpPr/>
          <p:nvPr/>
        </p:nvSpPr>
        <p:spPr>
          <a:xfrm>
            <a:off x="3141720" y="5508720"/>
            <a:ext cx="574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Ctr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TextBox 14"/>
          <p:cNvSpPr/>
          <p:nvPr/>
        </p:nvSpPr>
        <p:spPr>
          <a:xfrm>
            <a:off x="3933720" y="6711840"/>
            <a:ext cx="1441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t-RY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TextBox 3"/>
          <p:cNvSpPr/>
          <p:nvPr/>
        </p:nvSpPr>
        <p:spPr>
          <a:xfrm>
            <a:off x="2349360" y="324000"/>
            <a:ext cx="2374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</a:rPr>
              <a:t>Supplementary figure 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TextBox 25"/>
          <p:cNvSpPr/>
          <p:nvPr/>
        </p:nvSpPr>
        <p:spPr>
          <a:xfrm>
            <a:off x="692280" y="826920"/>
            <a:ext cx="287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TextBox 26"/>
          <p:cNvSpPr/>
          <p:nvPr/>
        </p:nvSpPr>
        <p:spPr>
          <a:xfrm>
            <a:off x="3716280" y="826920"/>
            <a:ext cx="289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TextBox 58"/>
          <p:cNvSpPr/>
          <p:nvPr/>
        </p:nvSpPr>
        <p:spPr>
          <a:xfrm>
            <a:off x="907920" y="3564000"/>
            <a:ext cx="289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TextBox 58"/>
          <p:cNvSpPr/>
          <p:nvPr/>
        </p:nvSpPr>
        <p:spPr>
          <a:xfrm>
            <a:off x="981000" y="5508720"/>
            <a:ext cx="289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TextBox 11"/>
          <p:cNvSpPr/>
          <p:nvPr/>
        </p:nvSpPr>
        <p:spPr>
          <a:xfrm>
            <a:off x="404640" y="7451640"/>
            <a:ext cx="6191280" cy="10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4 Effects of direct LPS treatment on isolated adult cardiomyocytes.</a:t>
            </a:r>
            <a:r>
              <a:rPr b="0" lang="en-GB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GB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 </a:t>
            </a:r>
            <a:r>
              <a:rPr b="0" lang="en-GB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ytoplasmic phospholipase A2 (cPLA2) an </a:t>
            </a:r>
            <a:r>
              <a:rPr b="1" lang="en-GB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B)</a:t>
            </a:r>
            <a:r>
              <a:rPr b="0" lang="en-GB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Protein kinase A (PKA) activities were measured in isolated adult cardiomyocytes from RASSF1A</a:t>
            </a:r>
            <a:r>
              <a:rPr b="0" lang="en-GB" sz="11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-/-</a:t>
            </a:r>
            <a:r>
              <a:rPr b="0" lang="en-GB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mice and WT littermates treated with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 </a:t>
            </a:r>
            <a:r>
              <a:rPr b="0" lang="en-US" sz="11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/ml </a:t>
            </a:r>
            <a:r>
              <a:rPr b="0" lang="en-GB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or 60 minutes. </a:t>
            </a:r>
            <a:r>
              <a:rPr b="0" lang="en-GB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o significant difference was observed between WT and RASSF1A</a:t>
            </a:r>
            <a:r>
              <a:rPr b="0" lang="en-GB" sz="11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-/- </a:t>
            </a:r>
            <a:r>
              <a:rPr b="0" lang="en-GB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yocytes. (C) The level of LTCC and (D) RYR phosphorylation were not different bewteen RASSF1A</a:t>
            </a:r>
            <a:r>
              <a:rPr b="0" lang="en-GB" sz="11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-/- </a:t>
            </a:r>
            <a:r>
              <a:rPr b="0" lang="en-GB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d WT myocytes after LPS treatment. Cells treated with isoproterenol (Iso) served as positive controls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8" name="Slide Number Placeholder 1"/>
          <p:cNvSpPr/>
          <p:nvPr/>
        </p:nvSpPr>
        <p:spPr>
          <a:xfrm>
            <a:off x="4915080" y="8475840"/>
            <a:ext cx="1600200" cy="48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29" name="Picture 2" descr="figure to explain lps treatment.png"/>
          <p:cNvPicPr/>
          <p:nvPr/>
        </p:nvPicPr>
        <p:blipFill>
          <a:blip r:embed="rId1"/>
          <a:srcRect l="5901" t="9390" r="0" b="26197"/>
          <a:stretch/>
        </p:blipFill>
        <p:spPr>
          <a:xfrm>
            <a:off x="1052640" y="1116000"/>
            <a:ext cx="4897440" cy="2513160"/>
          </a:xfrm>
          <a:prstGeom prst="rect">
            <a:avLst/>
          </a:prstGeom>
          <a:ln w="0">
            <a:noFill/>
          </a:ln>
        </p:spPr>
      </p:pic>
      <p:sp>
        <p:nvSpPr>
          <p:cNvPr id="230" name="TextBox 3"/>
          <p:cNvSpPr/>
          <p:nvPr/>
        </p:nvSpPr>
        <p:spPr>
          <a:xfrm>
            <a:off x="2349360" y="324000"/>
            <a:ext cx="2374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</a:rPr>
              <a:t>Supplementary figure 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Rectangle 1"/>
          <p:cNvSpPr/>
          <p:nvPr/>
        </p:nvSpPr>
        <p:spPr>
          <a:xfrm>
            <a:off x="304920" y="3624120"/>
            <a:ext cx="636408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Times New Roman"/>
                <a:ea typeface="Calibri"/>
              </a:rPr>
              <a:t>Supplementary Figure 5. </a:t>
            </a:r>
            <a:r>
              <a:rPr b="0" lang="en-GB" sz="1100" spc="-1" strike="noStrike">
                <a:solidFill>
                  <a:srgbClr val="000000"/>
                </a:solidFill>
                <a:latin typeface="Times New Roman"/>
                <a:ea typeface="Calibri"/>
              </a:rPr>
              <a:t>Schematic diagram showing the possible mechanism of reduced contractility found in RASSF1A</a:t>
            </a:r>
            <a:r>
              <a:rPr b="0" lang="en-GB" sz="1100" spc="-1" strike="noStrike" baseline="30000">
                <a:solidFill>
                  <a:srgbClr val="000000"/>
                </a:solidFill>
                <a:latin typeface="Times New Roman"/>
                <a:ea typeface="Calibri"/>
              </a:rPr>
              <a:t>-/- </a:t>
            </a:r>
            <a:r>
              <a:rPr b="0" lang="en-GB" sz="1100" spc="-1" strike="noStrike">
                <a:solidFill>
                  <a:srgbClr val="000000"/>
                </a:solidFill>
                <a:latin typeface="Times New Roman"/>
                <a:ea typeface="Calibri"/>
              </a:rPr>
              <a:t>mice following LPS treatment. </a:t>
            </a:r>
            <a:r>
              <a:rPr b="1" lang="en-GB" sz="1100" spc="-1" strike="noStrike">
                <a:solidFill>
                  <a:srgbClr val="000000"/>
                </a:solidFill>
                <a:latin typeface="Times New Roman"/>
                <a:ea typeface="Calibri"/>
              </a:rPr>
              <a:t>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5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5-07T11:45:22Z</dcterms:created>
  <dc:creator>mhshelp</dc:creator>
  <dc:description/>
  <dc:language>en-US</dc:language>
  <cp:lastModifiedBy>Delvac Oceandy</cp:lastModifiedBy>
  <dcterms:modified xsi:type="dcterms:W3CDTF">2014-04-11T14:00:39Z</dcterms:modified>
  <cp:revision>43</cp:revision>
  <dc:subject/>
  <dc:title>Slide 1</dc:title>
</cp:coreProperties>
</file>